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74" r:id="rId5"/>
    <p:sldId id="267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3" autoAdjust="0"/>
    <p:restoredTop sz="94660"/>
  </p:normalViewPr>
  <p:slideViewPr>
    <p:cSldViewPr snapToGrid="0">
      <p:cViewPr varScale="1">
        <p:scale>
          <a:sx n="89" d="100"/>
          <a:sy n="89" d="100"/>
        </p:scale>
        <p:origin x="68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1FE513-FE6E-0646-5E52-88F6CEB4E6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585A1E3-DFE6-0E9A-C7EC-5F6CB631CF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E56997-3596-40E4-B0E3-4D60CA963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0342C6E-4DCD-FC9D-28BA-A7AB36A72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9E9D26-EEC0-85A2-D89B-5E165E1AA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868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5014DD-7AF4-5112-0B0D-5BC8A93C3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2982557-B948-4BEE-5BCE-D4B32D1E20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F37AFB-FAE4-0753-5DCA-DFE052311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491004-D186-0D25-0493-017853D40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0CCF03-FBCB-1990-0F23-42390655C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532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82035DF-999A-D386-19CC-53BF5FEFDE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905D8FE-B3E2-5B2C-6E54-858569BB74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89A1C9-DBF6-D825-9010-1A9CEDB32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E08443-CF36-9B96-7949-EFE634154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4AB1782-82EF-6B93-06BD-4FE31DCD6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390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22401F-1F56-5A06-7DDC-7042F76D69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0CBCEF3-B322-E9B2-567B-FAA7051E33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620FBA-17D9-F86C-7ACF-AE55ECE55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5B6CE5-0409-620F-DC55-206B4591E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DCF327A-3A55-13B7-6098-913D73546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9879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AA6F17-805F-F5B4-374B-AD75A1F153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BFB59B-ED09-CA6E-16A3-4BEDABE0F9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AD93B4-5CB0-469D-D33C-BF08A11AB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F6C73D-E43E-76EB-3F91-5DB9E0836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E0ECC0-30B5-4DB3-19D6-2EC9D2D1E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0530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C6993C-3778-C69A-BAB7-85244B4B4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8421AA7-E74E-EADA-BD0C-77930A4D99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69AC822-99AE-41B3-0288-F1A7A41DB7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051BAAB-0CE3-48D4-5673-92F7BC91D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0CDFE20-4453-4117-34D5-AF2DFB27A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F5B50D-A276-EF13-87D8-97F42254C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016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035510-96D5-6A7C-3C7E-AEFFB77B2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903D823-B73D-FE66-1210-0B55BB673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3C9B097-206F-D157-9D12-671FA80763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DD8D9AC-BF40-FF40-6D48-0599109B3D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A862AA8-0B67-1BE1-05DB-9E28A44750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619CADF-9C57-0C2C-2B1C-FBA1EC7F7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81F9DF6-7168-3110-C8AF-CE50178DE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26389C1-3BD3-CBF2-EABC-E3037E38A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462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201941-282E-09E1-6B65-2D7E003652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FE7E0C7-19B3-651A-A180-19C3D0D8E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57DB4A7-AA37-9E3D-705B-A392D9811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6AB6211-BD8A-B0F9-0434-858873426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7581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EE7D6D1-A0D9-5267-82AE-3962D8BA3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FF8BDF4-7757-ADC2-BA0E-62146F63C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158F8F4-14B0-F7FD-45A4-9DBADE0D2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9884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D75E64-67D0-D8E8-35DC-7D97F4AF1F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1E7894A-8EFE-FF7C-235B-E083EACA6F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A6FEBB2-8726-4073-92EE-25DE10608C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BB042F3-F920-4613-EC11-7A49C6944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283161-6415-F8CE-F995-26FBA0C40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49754CC-2955-B864-3AA8-8DC102827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8839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51A5F9-245C-5A78-DA11-5E608EDDE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27EDD77-7E83-C63F-FF06-A4DE776B85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F42DD61-D171-73FD-A472-1C186640B6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78FF9B6-857B-2353-E596-F47AE79D9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F028E42-09DE-2399-1EC9-F0FAB67AE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C3594B-0665-4AF1-CB12-D2A27527D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7148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C05D2F7-9553-398D-6DCF-9052D432AE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41F75D3-5B08-5A84-742E-A6E41C1950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34FAD7-A4FB-B2B5-14CF-6DEB59ED6B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71544-D04A-44FE-BCF8-D96CEF2F0E1C}" type="datetimeFigureOut">
              <a:rPr kumimoji="1" lang="ja-JP" altLang="en-US" smtClean="0"/>
              <a:t>2023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5C719C-3C60-4711-59EE-8A9C5C8C65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DA05B4-5CF2-566F-DA2B-F8E0A32392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8D557-16D8-4E04-8752-89E4DB032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438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1D18BD5-4883-C691-5DC1-3552CD654956}"/>
              </a:ext>
            </a:extLst>
          </p:cNvPr>
          <p:cNvSpPr txBox="1"/>
          <p:nvPr/>
        </p:nvSpPr>
        <p:spPr>
          <a:xfrm>
            <a:off x="366711" y="278606"/>
            <a:ext cx="4748214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2400" dirty="0">
                <a:latin typeface="Calibri"/>
                <a:ea typeface="游ゴシック"/>
                <a:cs typeface="Calibri"/>
              </a:rPr>
              <a:t>Supplementary Figure S1</a:t>
            </a:r>
            <a:endParaRPr lang="ja-JP" altLang="en-US" sz="2400">
              <a:latin typeface="Calibri"/>
              <a:ea typeface="游ゴシック"/>
              <a:cs typeface="Calibri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E5252C-2C79-BAD7-B885-813C08F0D3EF}"/>
              </a:ext>
            </a:extLst>
          </p:cNvPr>
          <p:cNvSpPr txBox="1"/>
          <p:nvPr/>
        </p:nvSpPr>
        <p:spPr>
          <a:xfrm>
            <a:off x="809630" y="1545444"/>
            <a:ext cx="471484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b="1" dirty="0">
                <a:effectLst/>
                <a:latin typeface="Calibri"/>
                <a:ea typeface="SimSun"/>
                <a:cs typeface="Times New Roman"/>
              </a:rPr>
              <a:t>(a)</a:t>
            </a:r>
            <a:endParaRPr lang="ja-JP" altLang="ja-JP" sz="1050" b="1">
              <a:effectLst/>
              <a:latin typeface="Calibri"/>
              <a:ea typeface="SimSun"/>
              <a:cs typeface="Times New Roman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352ABD7A-104F-AA41-0D6D-77853B8853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9471" y="1908161"/>
            <a:ext cx="4748213" cy="3225002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573A7A27-8159-05BD-FE89-838A72481C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32417" y="1908161"/>
            <a:ext cx="4748213" cy="3225002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A2AE601-9162-3060-629A-8F301EDA24FB}"/>
              </a:ext>
            </a:extLst>
          </p:cNvPr>
          <p:cNvSpPr txBox="1"/>
          <p:nvPr/>
        </p:nvSpPr>
        <p:spPr>
          <a:xfrm>
            <a:off x="799471" y="2578889"/>
            <a:ext cx="507831" cy="1607344"/>
          </a:xfrm>
          <a:prstGeom prst="rect">
            <a:avLst/>
          </a:prstGeom>
          <a:noFill/>
        </p:spPr>
        <p:txBody>
          <a:bodyPr vert="eaVert" wrap="square" lIns="91440" tIns="45720" rIns="91440" bIns="45720" rtlCol="0" anchor="t">
            <a:spAutoFit/>
          </a:bodyPr>
          <a:lstStyle/>
          <a:p>
            <a:r>
              <a:rPr kumimoji="1" lang="en-US" altLang="ja-JP" sz="1050" dirty="0">
                <a:latin typeface="Calibri"/>
                <a:ea typeface="游ゴシック"/>
                <a:cs typeface="Times New Roman"/>
              </a:rPr>
              <a:t>Progression-free survival (%)</a:t>
            </a:r>
            <a:endParaRPr lang="ja-JP" altLang="en-US" sz="1050">
              <a:latin typeface="Calibri"/>
              <a:ea typeface="游ゴシック"/>
              <a:cs typeface="Times New Roman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958577F-5538-7258-AC7C-52E7F4AB82DD}"/>
              </a:ext>
            </a:extLst>
          </p:cNvPr>
          <p:cNvSpPr txBox="1"/>
          <p:nvPr/>
        </p:nvSpPr>
        <p:spPr>
          <a:xfrm>
            <a:off x="5907285" y="2607466"/>
            <a:ext cx="507831" cy="1607344"/>
          </a:xfrm>
          <a:prstGeom prst="rect">
            <a:avLst/>
          </a:prstGeom>
          <a:noFill/>
        </p:spPr>
        <p:txBody>
          <a:bodyPr vert="eaVert" wrap="square" lIns="91440" tIns="45720" rIns="91440" bIns="45720" rtlCol="0" anchor="t">
            <a:spAutoFit/>
          </a:bodyPr>
          <a:lstStyle/>
          <a:p>
            <a:r>
              <a:rPr kumimoji="1" lang="en-US" altLang="ja-JP" sz="1050" dirty="0">
                <a:latin typeface="Calibri"/>
                <a:ea typeface="游ゴシック"/>
                <a:cs typeface="Times New Roman"/>
              </a:rPr>
              <a:t>Progression-free survival (%)</a:t>
            </a:r>
            <a:endParaRPr lang="ja-JP" altLang="en-US" sz="1050">
              <a:latin typeface="Calibri"/>
              <a:ea typeface="游ゴシック"/>
              <a:cs typeface="Times New Roman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1135B06-1E2B-90C3-CCE0-E2577F7E7968}"/>
              </a:ext>
            </a:extLst>
          </p:cNvPr>
          <p:cNvSpPr txBox="1"/>
          <p:nvPr/>
        </p:nvSpPr>
        <p:spPr>
          <a:xfrm>
            <a:off x="5057794" y="4550667"/>
            <a:ext cx="62749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sz="1050" dirty="0">
                <a:latin typeface="Calibri"/>
                <a:ea typeface="游ゴシック"/>
                <a:cs typeface="Times New Roman"/>
              </a:rPr>
              <a:t>months</a:t>
            </a:r>
            <a:endParaRPr lang="ja-JP" altLang="en-US" sz="1050">
              <a:latin typeface="Calibri"/>
              <a:ea typeface="游ゴシック"/>
              <a:cs typeface="Times New Roman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A9E834E-8CA9-315C-813E-3F52292B4EC5}"/>
              </a:ext>
            </a:extLst>
          </p:cNvPr>
          <p:cNvSpPr txBox="1"/>
          <p:nvPr/>
        </p:nvSpPr>
        <p:spPr>
          <a:xfrm>
            <a:off x="10044836" y="4543523"/>
            <a:ext cx="592247" cy="41549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sz="1050" dirty="0">
                <a:latin typeface="Calibri"/>
                <a:ea typeface="游ゴシック"/>
                <a:cs typeface="Times New Roman"/>
              </a:rPr>
              <a:t>months</a:t>
            </a:r>
            <a:endParaRPr lang="ja-JP" altLang="en-US" sz="1050">
              <a:latin typeface="Calibri"/>
              <a:ea typeface="游ゴシック"/>
              <a:cs typeface="Times New Roman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2D8DF57-63CF-44EC-11D1-0028484CA5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617026"/>
              </p:ext>
            </p:extLst>
          </p:nvPr>
        </p:nvGraphicFramePr>
        <p:xfrm>
          <a:off x="1116805" y="4768872"/>
          <a:ext cx="4276728" cy="62370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18808">
                  <a:extLst>
                    <a:ext uri="{9D8B030D-6E8A-4147-A177-3AD203B41FA5}">
                      <a16:colId xmlns:a16="http://schemas.microsoft.com/office/drawing/2014/main" val="888543144"/>
                    </a:ext>
                  </a:extLst>
                </a:gridCol>
                <a:gridCol w="243891">
                  <a:extLst>
                    <a:ext uri="{9D8B030D-6E8A-4147-A177-3AD203B41FA5}">
                      <a16:colId xmlns:a16="http://schemas.microsoft.com/office/drawing/2014/main" val="530829967"/>
                    </a:ext>
                  </a:extLst>
                </a:gridCol>
                <a:gridCol w="1130770">
                  <a:extLst>
                    <a:ext uri="{9D8B030D-6E8A-4147-A177-3AD203B41FA5}">
                      <a16:colId xmlns:a16="http://schemas.microsoft.com/office/drawing/2014/main" val="3559385396"/>
                    </a:ext>
                  </a:extLst>
                </a:gridCol>
                <a:gridCol w="273454">
                  <a:extLst>
                    <a:ext uri="{9D8B030D-6E8A-4147-A177-3AD203B41FA5}">
                      <a16:colId xmlns:a16="http://schemas.microsoft.com/office/drawing/2014/main" val="140380446"/>
                    </a:ext>
                  </a:extLst>
                </a:gridCol>
                <a:gridCol w="966795">
                  <a:extLst>
                    <a:ext uri="{9D8B030D-6E8A-4147-A177-3AD203B41FA5}">
                      <a16:colId xmlns:a16="http://schemas.microsoft.com/office/drawing/2014/main" val="994348651"/>
                    </a:ext>
                  </a:extLst>
                </a:gridCol>
                <a:gridCol w="428625">
                  <a:extLst>
                    <a:ext uri="{9D8B030D-6E8A-4147-A177-3AD203B41FA5}">
                      <a16:colId xmlns:a16="http://schemas.microsoft.com/office/drawing/2014/main" val="2973022375"/>
                    </a:ext>
                  </a:extLst>
                </a:gridCol>
                <a:gridCol w="814385">
                  <a:extLst>
                    <a:ext uri="{9D8B030D-6E8A-4147-A177-3AD203B41FA5}">
                      <a16:colId xmlns:a16="http://schemas.microsoft.com/office/drawing/2014/main" val="263171954"/>
                    </a:ext>
                  </a:extLst>
                </a:gridCol>
              </a:tblGrid>
              <a:tr h="206107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endParaRPr lang="ja-JP" sz="8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SimSun" panose="02010600030101010101" pitchFamily="2" charset="-122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5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5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2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25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0349362"/>
                  </a:ext>
                </a:extLst>
              </a:tr>
              <a:tr h="20879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AE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5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2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8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4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2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0317503"/>
                  </a:ext>
                </a:extLst>
              </a:tr>
              <a:tr h="20879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PD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58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42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23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11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3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1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9042490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EDBECE0-1C54-E36A-F65E-C64A9AD703B0}"/>
              </a:ext>
            </a:extLst>
          </p:cNvPr>
          <p:cNvSpPr txBox="1"/>
          <p:nvPr/>
        </p:nvSpPr>
        <p:spPr>
          <a:xfrm>
            <a:off x="713901" y="4722132"/>
            <a:ext cx="83106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dirty="0">
                <a:latin typeface="Calibri"/>
                <a:ea typeface="游ゴシック"/>
                <a:cs typeface="Times New Roman"/>
              </a:rPr>
              <a:t>No. at risk</a:t>
            </a:r>
            <a:endParaRPr lang="ja-JP" altLang="en-US" sz="1050">
              <a:latin typeface="Calibri"/>
              <a:ea typeface="游ゴシック"/>
              <a:cs typeface="Times New Roman"/>
            </a:endParaRPr>
          </a:p>
        </p:txBody>
      </p:sp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F28DA077-2DD5-E599-9BE6-7B9FD89FE5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2606205"/>
              </p:ext>
            </p:extLst>
          </p:nvPr>
        </p:nvGraphicFramePr>
        <p:xfrm>
          <a:off x="6276589" y="4744828"/>
          <a:ext cx="3602518" cy="62370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88534">
                  <a:extLst>
                    <a:ext uri="{9D8B030D-6E8A-4147-A177-3AD203B41FA5}">
                      <a16:colId xmlns:a16="http://schemas.microsoft.com/office/drawing/2014/main" val="888543144"/>
                    </a:ext>
                  </a:extLst>
                </a:gridCol>
                <a:gridCol w="300037">
                  <a:extLst>
                    <a:ext uri="{9D8B030D-6E8A-4147-A177-3AD203B41FA5}">
                      <a16:colId xmlns:a16="http://schemas.microsoft.com/office/drawing/2014/main" val="530829967"/>
                    </a:ext>
                  </a:extLst>
                </a:gridCol>
                <a:gridCol w="650081">
                  <a:extLst>
                    <a:ext uri="{9D8B030D-6E8A-4147-A177-3AD203B41FA5}">
                      <a16:colId xmlns:a16="http://schemas.microsoft.com/office/drawing/2014/main" val="3559385396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140380446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994348651"/>
                    </a:ext>
                  </a:extLst>
                </a:gridCol>
                <a:gridCol w="492919">
                  <a:extLst>
                    <a:ext uri="{9D8B030D-6E8A-4147-A177-3AD203B41FA5}">
                      <a16:colId xmlns:a16="http://schemas.microsoft.com/office/drawing/2014/main" val="2973022375"/>
                    </a:ext>
                  </a:extLst>
                </a:gridCol>
                <a:gridCol w="742247">
                  <a:extLst>
                    <a:ext uri="{9D8B030D-6E8A-4147-A177-3AD203B41FA5}">
                      <a16:colId xmlns:a16="http://schemas.microsoft.com/office/drawing/2014/main" val="263171954"/>
                    </a:ext>
                  </a:extLst>
                </a:gridCol>
              </a:tblGrid>
              <a:tr h="206107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endParaRPr lang="ja-JP" sz="8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SimSun" panose="02010600030101010101" pitchFamily="2" charset="-122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5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5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2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25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0349362"/>
                  </a:ext>
                </a:extLst>
              </a:tr>
              <a:tr h="20879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AE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2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7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3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3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1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0317503"/>
                  </a:ext>
                </a:extLst>
              </a:tr>
              <a:tr h="208798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PD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33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2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SimSun"/>
                          <a:cs typeface="Times New Roman"/>
                        </a:rPr>
                        <a:t>1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2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b="0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Times New Roman"/>
                        </a:rPr>
                        <a:t>0</a:t>
                      </a:r>
                      <a:endParaRPr lang="ja-JP" sz="800" b="0">
                        <a:solidFill>
                          <a:srgbClr val="000000"/>
                        </a:solidFill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9042490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48E972F-7845-22F0-7E73-70D55CFA7EA4}"/>
              </a:ext>
            </a:extLst>
          </p:cNvPr>
          <p:cNvSpPr txBox="1"/>
          <p:nvPr/>
        </p:nvSpPr>
        <p:spPr>
          <a:xfrm>
            <a:off x="5896778" y="4700700"/>
            <a:ext cx="83106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dirty="0">
                <a:latin typeface="Calibri"/>
                <a:ea typeface="游ゴシック"/>
                <a:cs typeface="Times New Roman"/>
              </a:rPr>
              <a:t>No. at risk</a:t>
            </a:r>
            <a:endParaRPr lang="ja-JP" altLang="en-US" sz="1050">
              <a:latin typeface="Calibri"/>
              <a:ea typeface="游ゴシック"/>
              <a:cs typeface="Times New Roman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0275FAC-4623-F66D-03DF-9305669CB1D7}"/>
              </a:ext>
            </a:extLst>
          </p:cNvPr>
          <p:cNvSpPr txBox="1"/>
          <p:nvPr/>
        </p:nvSpPr>
        <p:spPr>
          <a:xfrm>
            <a:off x="3271854" y="3006823"/>
            <a:ext cx="471473" cy="253916"/>
          </a:xfrm>
          <a:prstGeom prst="rect">
            <a:avLst/>
          </a:prstGeom>
          <a:solidFill>
            <a:srgbClr val="FF0000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dirty="0">
                <a:latin typeface="Calibri"/>
                <a:ea typeface="SimSun"/>
                <a:cs typeface="Times New Roman"/>
              </a:rPr>
              <a:t>AE</a:t>
            </a:r>
            <a:endParaRPr lang="ja-JP" altLang="ja-JP" sz="1050">
              <a:effectLst/>
              <a:latin typeface="Calibri"/>
              <a:ea typeface="SimSun"/>
              <a:cs typeface="Times New Roman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FD1B7B1-3FB9-F76B-C55B-EA6B37D537D3}"/>
              </a:ext>
            </a:extLst>
          </p:cNvPr>
          <p:cNvSpPr txBox="1"/>
          <p:nvPr/>
        </p:nvSpPr>
        <p:spPr>
          <a:xfrm>
            <a:off x="7693863" y="2756787"/>
            <a:ext cx="471473" cy="253916"/>
          </a:xfrm>
          <a:prstGeom prst="rect">
            <a:avLst/>
          </a:prstGeom>
          <a:solidFill>
            <a:srgbClr val="FF0000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dirty="0">
                <a:latin typeface="Calibri"/>
                <a:ea typeface="SimSun"/>
                <a:cs typeface="Times New Roman"/>
              </a:rPr>
              <a:t>AE</a:t>
            </a:r>
            <a:endParaRPr lang="ja-JP" altLang="ja-JP" sz="1050">
              <a:effectLst/>
              <a:latin typeface="Calibri"/>
              <a:ea typeface="SimSun"/>
              <a:cs typeface="Times New Roman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6CCC1EF-B9C4-BC2B-921E-405E7EACCC57}"/>
              </a:ext>
            </a:extLst>
          </p:cNvPr>
          <p:cNvSpPr txBox="1"/>
          <p:nvPr/>
        </p:nvSpPr>
        <p:spPr>
          <a:xfrm>
            <a:off x="2326493" y="3377600"/>
            <a:ext cx="471473" cy="253916"/>
          </a:xfrm>
          <a:prstGeom prst="rect">
            <a:avLst/>
          </a:prstGeom>
          <a:solidFill>
            <a:srgbClr val="00B0F0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dirty="0">
                <a:effectLst/>
                <a:latin typeface="Calibri"/>
                <a:ea typeface="SimSun"/>
                <a:cs typeface="Times New Roman"/>
              </a:rPr>
              <a:t>PD</a:t>
            </a:r>
            <a:endParaRPr lang="ja-JP" altLang="ja-JP" sz="1050">
              <a:effectLst/>
              <a:latin typeface="Calibri"/>
              <a:ea typeface="SimSun"/>
              <a:cs typeface="Times New Roman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88F91D6-8202-853A-2A8C-66B34F1D2528}"/>
              </a:ext>
            </a:extLst>
          </p:cNvPr>
          <p:cNvSpPr txBox="1"/>
          <p:nvPr/>
        </p:nvSpPr>
        <p:spPr>
          <a:xfrm>
            <a:off x="6948528" y="3470471"/>
            <a:ext cx="471473" cy="253916"/>
          </a:xfrm>
          <a:prstGeom prst="rect">
            <a:avLst/>
          </a:prstGeom>
          <a:solidFill>
            <a:srgbClr val="00B0F0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dirty="0">
                <a:effectLst/>
                <a:latin typeface="Calibri"/>
                <a:ea typeface="SimSun"/>
                <a:cs typeface="Times New Roman"/>
              </a:rPr>
              <a:t>PD</a:t>
            </a:r>
            <a:endParaRPr lang="ja-JP" altLang="ja-JP" sz="1050">
              <a:effectLst/>
              <a:latin typeface="Calibri"/>
              <a:ea typeface="SimSun"/>
              <a:cs typeface="Times New Roman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A22D3F2-2CC2-E719-4B1D-53039B9204E1}"/>
              </a:ext>
            </a:extLst>
          </p:cNvPr>
          <p:cNvSpPr txBox="1"/>
          <p:nvPr/>
        </p:nvSpPr>
        <p:spPr>
          <a:xfrm>
            <a:off x="3690973" y="2054580"/>
            <a:ext cx="1588279" cy="57708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b="1" dirty="0">
                <a:latin typeface="Calibri"/>
                <a:ea typeface="SimSun"/>
                <a:cs typeface="Times New Roman"/>
              </a:rPr>
              <a:t>HR = 2.79 </a:t>
            </a:r>
          </a:p>
          <a:p>
            <a:r>
              <a:rPr lang="en-US" altLang="ja-JP" sz="1050" b="1" dirty="0">
                <a:latin typeface="Calibri"/>
                <a:ea typeface="SimSun"/>
                <a:cs typeface="Times New Roman"/>
              </a:rPr>
              <a:t>(95% CI = 0.98–7.87)</a:t>
            </a:r>
          </a:p>
          <a:p>
            <a:r>
              <a:rPr lang="en-US" altLang="ja-JP" sz="1050" b="1" dirty="0">
                <a:effectLst/>
                <a:latin typeface="Calibri"/>
                <a:ea typeface="SimSun"/>
                <a:cs typeface="Times New Roman"/>
              </a:rPr>
              <a:t>P = 0.0523</a:t>
            </a:r>
            <a:endParaRPr lang="ja-JP" altLang="ja-JP" sz="1050" b="1" dirty="0">
              <a:effectLst/>
              <a:latin typeface="Calibri"/>
              <a:ea typeface="SimSun"/>
              <a:cs typeface="Times New Roman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3ED3E42-50AA-1094-D15D-5F93ED015EA9}"/>
              </a:ext>
            </a:extLst>
          </p:cNvPr>
          <p:cNvSpPr txBox="1"/>
          <p:nvPr/>
        </p:nvSpPr>
        <p:spPr>
          <a:xfrm>
            <a:off x="8712899" y="1985753"/>
            <a:ext cx="1724209" cy="57708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b="1" dirty="0">
                <a:latin typeface="Calibri"/>
                <a:ea typeface="SimSun"/>
                <a:cs typeface="Times New Roman"/>
              </a:rPr>
              <a:t>HR = 4.02 </a:t>
            </a:r>
          </a:p>
          <a:p>
            <a:r>
              <a:rPr lang="en-US" altLang="ja-JP" sz="1050" b="1" dirty="0">
                <a:latin typeface="Calibri"/>
                <a:ea typeface="SimSun"/>
                <a:cs typeface="Times New Roman"/>
              </a:rPr>
              <a:t>(95% CI = 1.20–13.44)</a:t>
            </a:r>
          </a:p>
          <a:p>
            <a:r>
              <a:rPr lang="en-US" altLang="ja-JP" sz="1050" b="1" dirty="0">
                <a:effectLst/>
                <a:latin typeface="Calibri"/>
                <a:ea typeface="SimSun"/>
                <a:cs typeface="Times New Roman"/>
              </a:rPr>
              <a:t>P = 0.0239</a:t>
            </a:r>
            <a:endParaRPr lang="ja-JP" altLang="ja-JP" sz="1050" b="1" dirty="0">
              <a:effectLst/>
              <a:latin typeface="Calibri"/>
              <a:ea typeface="SimSun"/>
              <a:cs typeface="Times New Roman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FE277B0-9D1E-89A5-BBE5-B85ECE0EF40A}"/>
              </a:ext>
            </a:extLst>
          </p:cNvPr>
          <p:cNvSpPr txBox="1"/>
          <p:nvPr/>
        </p:nvSpPr>
        <p:spPr>
          <a:xfrm>
            <a:off x="5932417" y="1547832"/>
            <a:ext cx="471484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050" b="1" dirty="0">
                <a:effectLst/>
                <a:latin typeface="Calibri"/>
                <a:ea typeface="SimSun"/>
                <a:cs typeface="Times New Roman"/>
              </a:rPr>
              <a:t>(b)</a:t>
            </a:r>
            <a:endParaRPr lang="ja-JP" altLang="ja-JP" sz="1050" b="1">
              <a:effectLst/>
              <a:latin typeface="Calibri"/>
              <a:ea typeface="SimSun"/>
              <a:cs typeface="Times New Roman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BFA8B65-7013-3AD8-DDE8-74E6A3B2C31B}"/>
              </a:ext>
            </a:extLst>
          </p:cNvPr>
          <p:cNvSpPr txBox="1"/>
          <p:nvPr/>
        </p:nvSpPr>
        <p:spPr>
          <a:xfrm>
            <a:off x="520861" y="968875"/>
            <a:ext cx="1063053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Progression free survival according to Reason of discontinuation by first line treatment. Rates were estimated using the Kaplan–Meier method. (a) In first line IO-IO treatment cases, (b) In first line IO-TKI treatment cases.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42803974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8ED0E62C-CB91-2CC0-FD5E-7AA61CF133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3854872"/>
              </p:ext>
            </p:extLst>
          </p:nvPr>
        </p:nvGraphicFramePr>
        <p:xfrm>
          <a:off x="4010031" y="404020"/>
          <a:ext cx="7212808" cy="628594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412333">
                  <a:extLst>
                    <a:ext uri="{9D8B030D-6E8A-4147-A177-3AD203B41FA5}">
                      <a16:colId xmlns:a16="http://schemas.microsoft.com/office/drawing/2014/main" val="850144743"/>
                    </a:ext>
                  </a:extLst>
                </a:gridCol>
                <a:gridCol w="2135981">
                  <a:extLst>
                    <a:ext uri="{9D8B030D-6E8A-4147-A177-3AD203B41FA5}">
                      <a16:colId xmlns:a16="http://schemas.microsoft.com/office/drawing/2014/main" val="3970378502"/>
                    </a:ext>
                  </a:extLst>
                </a:gridCol>
                <a:gridCol w="1664494">
                  <a:extLst>
                    <a:ext uri="{9D8B030D-6E8A-4147-A177-3AD203B41FA5}">
                      <a16:colId xmlns:a16="http://schemas.microsoft.com/office/drawing/2014/main" val="2683802180"/>
                    </a:ext>
                  </a:extLst>
                </a:gridCol>
              </a:tblGrid>
              <a:tr h="949469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zh-CN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r>
                        <a:rPr lang="zh-CN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y grade (%)</a:t>
                      </a:r>
                    </a:p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de ≥ </a:t>
                      </a:r>
                      <a:r>
                        <a:rPr lang="en-US" altLang="ja-JP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(%)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63126935"/>
                  </a:ext>
                </a:extLst>
              </a:tr>
              <a:tr h="3043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Edema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600294698"/>
                  </a:ext>
                </a:extLst>
              </a:tr>
              <a:tr h="308296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cle pain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00772441"/>
                  </a:ext>
                </a:extLst>
              </a:tr>
              <a:tr h="3043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reatinine increase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246436892"/>
                  </a:ext>
                </a:extLst>
              </a:tr>
              <a:tr h="308296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pes zoster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795101749"/>
                  </a:ext>
                </a:extLst>
              </a:tr>
              <a:tr h="308296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omnia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703989042"/>
                  </a:ext>
                </a:extLst>
              </a:tr>
              <a:tr h="3043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Difficulty breathing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696010746"/>
                  </a:ext>
                </a:extLst>
              </a:tr>
              <a:tr h="308296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ep vein thrombosis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790002203"/>
                  </a:ext>
                </a:extLst>
              </a:tr>
              <a:tr h="435535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teonecrosis of the jaw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887059183"/>
                  </a:ext>
                </a:extLst>
              </a:tr>
              <a:tr h="308296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sebleed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621554158"/>
                  </a:ext>
                </a:extLst>
              </a:tr>
              <a:tr h="308296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openia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276874672"/>
                  </a:ext>
                </a:extLst>
              </a:tr>
              <a:tr h="308296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Alopecia 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709994801"/>
                  </a:ext>
                </a:extLst>
              </a:tr>
              <a:tr h="308296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al damage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850207110"/>
                  </a:ext>
                </a:extLst>
              </a:tr>
              <a:tr h="3043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ancreatitis 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007740580"/>
                  </a:ext>
                </a:extLst>
              </a:tr>
              <a:tr h="3043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Enterocutaneous fistula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10790565"/>
                  </a:ext>
                </a:extLst>
              </a:tr>
              <a:tr h="3043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Hypoalbuminemia 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891561324"/>
                  </a:ext>
                </a:extLst>
              </a:tr>
              <a:tr h="3043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Adrenal insufficiency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041116958"/>
                  </a:ext>
                </a:extLst>
              </a:tr>
              <a:tr h="304322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Anemia</a:t>
                      </a:r>
                      <a:endParaRPr lang="ja-JP" sz="8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</a:pPr>
                      <a:r>
                        <a:rPr lang="en-US" altLang="ja-JP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040758189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9DA3B94-8F3B-E407-7A4F-3AE61AE2DB8E}"/>
              </a:ext>
            </a:extLst>
          </p:cNvPr>
          <p:cNvSpPr txBox="1"/>
          <p:nvPr/>
        </p:nvSpPr>
        <p:spPr>
          <a:xfrm>
            <a:off x="0" y="38652"/>
            <a:ext cx="7958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Yu Gothic (Body)"/>
                <a:cs typeface="Times New Roman" panose="02020603050405020304" pitchFamily="18" charset="0"/>
              </a:rPr>
              <a:t>Supplementary Table </a:t>
            </a:r>
            <a:r>
              <a:rPr kumimoji="1" lang="en-US" altLang="ja-JP" dirty="0" err="1">
                <a:latin typeface="Yu Gothic (Body)"/>
                <a:cs typeface="Times New Roman" panose="02020603050405020304" pitchFamily="18" charset="0"/>
              </a:rPr>
              <a:t>S1</a:t>
            </a:r>
            <a:endParaRPr kumimoji="1" lang="ja-JP" altLang="en-US" dirty="0">
              <a:latin typeface="Yu Gothic (Body)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0488390-A34B-1A7F-C27E-9F2C46FD4509}"/>
              </a:ext>
            </a:extLst>
          </p:cNvPr>
          <p:cNvSpPr txBox="1"/>
          <p:nvPr/>
        </p:nvSpPr>
        <p:spPr>
          <a:xfrm>
            <a:off x="100013" y="892969"/>
            <a:ext cx="362902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dverse events that occurred in only one patient of second-line </a:t>
            </a:r>
            <a:r>
              <a:rPr lang="en-US" altLang="ja-JP" sz="105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abozantinib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484142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7" ma:contentTypeDescription="Create a new document." ma:contentTypeScope="" ma:versionID="5165936aa9f2912f9b3ae55fe8d025dc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0cfa769a4cc3808a33fc7f3bfc03fd14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FF9ABCC-C5C0-4B84-A765-8EA7DCC6BEFC}">
  <ds:schemaRefs>
    <ds:schemaRef ds:uri="http://schemas.microsoft.com/office/2006/metadata/properties"/>
    <ds:schemaRef ds:uri="http://schemas.microsoft.com/office/infopath/2007/PartnerControls"/>
    <ds:schemaRef ds:uri="22d571ce-5d5e-4577-851b-36fe2b87e29c"/>
    <ds:schemaRef ds:uri="7805362c-7fb7-47ff-9049-83b2c46e6485"/>
  </ds:schemaRefs>
</ds:datastoreItem>
</file>

<file path=customXml/itemProps2.xml><?xml version="1.0" encoding="utf-8"?>
<ds:datastoreItem xmlns:ds="http://schemas.openxmlformats.org/officeDocument/2006/customXml" ds:itemID="{0C0C4E46-A3A2-407C-87D1-2E8D351912A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611FA73-9156-49E6-858F-24CE59B3903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85</TotalTime>
  <Words>225</Words>
  <Application>Microsoft Office PowerPoint</Application>
  <PresentationFormat>ワイド画面</PresentationFormat>
  <Paragraphs>11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Yu Gothic (Body)</vt:lpstr>
      <vt:lpstr>游ゴシック</vt:lpstr>
      <vt:lpstr>游ゴシック Light</vt:lpstr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b</dc:title>
  <dc:creator>佐塚 智和</dc:creator>
  <cp:lastModifiedBy>佐塚 智和</cp:lastModifiedBy>
  <cp:revision>80</cp:revision>
  <dcterms:created xsi:type="dcterms:W3CDTF">2023-07-21T04:46:21Z</dcterms:created>
  <dcterms:modified xsi:type="dcterms:W3CDTF">2023-08-24T04:07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  <property fmtid="{D5CDD505-2E9C-101B-9397-08002B2CF9AE}" pid="3" name="MediaServiceImageTags">
    <vt:lpwstr/>
  </property>
</Properties>
</file>